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827" autoAdjust="0"/>
    <p:restoredTop sz="95501" autoAdjust="0"/>
  </p:normalViewPr>
  <p:slideViewPr>
    <p:cSldViewPr>
      <p:cViewPr varScale="1">
        <p:scale>
          <a:sx n="167" d="100"/>
          <a:sy n="167" d="100"/>
        </p:scale>
        <p:origin x="-252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8439D-5B4D-4A0F-9289-83C55D3F04DA}" type="datetimeFigureOut">
              <a:rPr lang="en-US" smtClean="0"/>
              <a:t>5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99C3C-C04D-4110-85F0-2B100E434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844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8439D-5B4D-4A0F-9289-83C55D3F04DA}" type="datetimeFigureOut">
              <a:rPr lang="en-US" smtClean="0"/>
              <a:t>5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99C3C-C04D-4110-85F0-2B100E434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047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8439D-5B4D-4A0F-9289-83C55D3F04DA}" type="datetimeFigureOut">
              <a:rPr lang="en-US" smtClean="0"/>
              <a:t>5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99C3C-C04D-4110-85F0-2B100E434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2179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8439D-5B4D-4A0F-9289-83C55D3F04DA}" type="datetimeFigureOut">
              <a:rPr lang="en-US" smtClean="0"/>
              <a:t>5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99C3C-C04D-4110-85F0-2B100E434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236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8439D-5B4D-4A0F-9289-83C55D3F04DA}" type="datetimeFigureOut">
              <a:rPr lang="en-US" smtClean="0"/>
              <a:t>5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99C3C-C04D-4110-85F0-2B100E434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233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8439D-5B4D-4A0F-9289-83C55D3F04DA}" type="datetimeFigureOut">
              <a:rPr lang="en-US" smtClean="0"/>
              <a:t>5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99C3C-C04D-4110-85F0-2B100E434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0315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8439D-5B4D-4A0F-9289-83C55D3F04DA}" type="datetimeFigureOut">
              <a:rPr lang="en-US" smtClean="0"/>
              <a:t>5/2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99C3C-C04D-4110-85F0-2B100E434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484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8439D-5B4D-4A0F-9289-83C55D3F04DA}" type="datetimeFigureOut">
              <a:rPr lang="en-US" smtClean="0"/>
              <a:t>5/2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99C3C-C04D-4110-85F0-2B100E434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901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8439D-5B4D-4A0F-9289-83C55D3F04DA}" type="datetimeFigureOut">
              <a:rPr lang="en-US" smtClean="0"/>
              <a:t>5/2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99C3C-C04D-4110-85F0-2B100E434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573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8439D-5B4D-4A0F-9289-83C55D3F04DA}" type="datetimeFigureOut">
              <a:rPr lang="en-US" smtClean="0"/>
              <a:t>5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99C3C-C04D-4110-85F0-2B100E434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527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8439D-5B4D-4A0F-9289-83C55D3F04DA}" type="datetimeFigureOut">
              <a:rPr lang="en-US" smtClean="0"/>
              <a:t>5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99C3C-C04D-4110-85F0-2B100E434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321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48439D-5B4D-4A0F-9289-83C55D3F04DA}" type="datetimeFigureOut">
              <a:rPr lang="en-US" smtClean="0"/>
              <a:t>5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499C3C-C04D-4110-85F0-2B100E434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450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312439" y="228600"/>
            <a:ext cx="8602961" cy="4793397"/>
            <a:chOff x="312439" y="228600"/>
            <a:chExt cx="8602961" cy="4793397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3400" y="1049923"/>
              <a:ext cx="3575050" cy="2987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312439" y="228600"/>
              <a:ext cx="16674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pl. Figure 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29858" y="838200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163658" y="880646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29858" y="4191000"/>
              <a:ext cx="8485542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pl. Figure 1.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A)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iR-21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nd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iR-224 expression levels in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CC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umors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 different stages (I,II,III,IV) assessed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y real-time RT-PCR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alysis and normalized to control liver tissues.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ata are represented as mean ± SE. ***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&lt;0.001, in comparison to control.</a:t>
              </a:r>
            </a:p>
            <a:p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11980" y="1049923"/>
              <a:ext cx="3508375" cy="2987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5196787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52400" y="228600"/>
            <a:ext cx="8622702" cy="4292263"/>
            <a:chOff x="152400" y="228600"/>
            <a:chExt cx="8622702" cy="4292263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57400" y="1115284"/>
              <a:ext cx="2581152" cy="198120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52400" y="228600"/>
              <a:ext cx="16674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pl. Figure 2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04800" y="810484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806173" y="810484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29200" y="1158792"/>
              <a:ext cx="1396211" cy="2057400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4697058" y="810484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90623" y="1098383"/>
              <a:ext cx="1491377" cy="2178217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6678258" y="810484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89560" y="3505200"/>
              <a:ext cx="8485542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pl. Figure 2.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ffects of miR-9 overexpression on 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pG2 cancer properties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 Relative miR-9 expression levels in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pG2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ells after transfection with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control or miR-9, 48h post-transfection. (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 Cell growth of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pG2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iver cancer cells transfected with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negative control (</a:t>
              </a:r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trl)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or miR-9, 48h and 72h post-transfection. (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 Invasion of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pG2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fter transfection with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negative control (</a:t>
              </a:r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trl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 or miR-9, 48h post-transfection. (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 Soft agar colony assay in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pG2 cells overexpressing </a:t>
              </a:r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egative control (</a:t>
              </a:r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trl) or miR-9.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ll data are represented as mean ± SE. ***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&lt;0.001, **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&lt;0.01.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Picture 3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7200" y="1098383"/>
              <a:ext cx="1244580" cy="1998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480271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52400" y="228600"/>
            <a:ext cx="8622702" cy="3922931"/>
            <a:chOff x="152400" y="228600"/>
            <a:chExt cx="8622702" cy="3922931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19200" y="1067059"/>
              <a:ext cx="1304925" cy="1828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>
              <a:off x="152400" y="228600"/>
              <a:ext cx="16674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pl. Figure 3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89560" y="3505200"/>
              <a:ext cx="848554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pl. Figure 3. PPARA relative mRNA levels after CDH1 inhibition in SNU-449 cells.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PARA mRNA levels were measured by </a:t>
              </a:r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qPCR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nalysis in SNU-449 cells transfected with an siRNA negative control (</a:t>
              </a:r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NC) and an siRNA against CDH1 (si-CDH1), 48h post-transfection.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1454132" y="2765054"/>
              <a:ext cx="685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NC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835132" y="2768453"/>
              <a:ext cx="76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-CDH1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789732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4</TotalTime>
  <Words>238</Words>
  <Application>Microsoft Office PowerPoint</Application>
  <PresentationFormat>On-screen Show (4:3)</PresentationFormat>
  <Paragraphs>14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s Polytarchou</dc:creator>
  <cp:lastModifiedBy>Iliopoulos, Dimitrios</cp:lastModifiedBy>
  <cp:revision>55</cp:revision>
  <dcterms:created xsi:type="dcterms:W3CDTF">2014-05-28T23:48:30Z</dcterms:created>
  <dcterms:modified xsi:type="dcterms:W3CDTF">2015-05-20T19:43:42Z</dcterms:modified>
</cp:coreProperties>
</file>